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61"/>
    <p:restoredTop sz="94678"/>
  </p:normalViewPr>
  <p:slideViewPr>
    <p:cSldViewPr snapToGrid="0" snapToObjects="1">
      <p:cViewPr>
        <p:scale>
          <a:sx n="138" d="100"/>
          <a:sy n="138" d="100"/>
        </p:scale>
        <p:origin x="1728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77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782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604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647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59079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6476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371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171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400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02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5596E9-F1A3-9140-B45A-F3CD60641B70}" type="datetimeFigureOut">
              <a:rPr lang="en-US" smtClean="0"/>
              <a:t>6/2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D4C593-040C-6B4E-964F-EAAA062EC3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123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91">
            <a:extLst>
              <a:ext uri="{FF2B5EF4-FFF2-40B4-BE49-F238E27FC236}">
                <a16:creationId xmlns:a16="http://schemas.microsoft.com/office/drawing/2014/main" id="{B8CE5847-2B23-624C-B898-25996AC3B901}"/>
              </a:ext>
            </a:extLst>
          </p:cNvPr>
          <p:cNvSpPr/>
          <p:nvPr/>
        </p:nvSpPr>
        <p:spPr>
          <a:xfrm>
            <a:off x="58004" y="898382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EFC13851-8D6E-3F4A-A9DF-622597C261F7}"/>
              </a:ext>
            </a:extLst>
          </p:cNvPr>
          <p:cNvSpPr/>
          <p:nvPr/>
        </p:nvSpPr>
        <p:spPr>
          <a:xfrm>
            <a:off x="58004" y="836633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148F2A4E-750C-CA49-9AFF-2369BFAC34EA}"/>
              </a:ext>
            </a:extLst>
          </p:cNvPr>
          <p:cNvSpPr/>
          <p:nvPr/>
        </p:nvSpPr>
        <p:spPr>
          <a:xfrm>
            <a:off x="58004" y="7767038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66F12AE8-7078-434B-9767-CA780926F647}"/>
              </a:ext>
            </a:extLst>
          </p:cNvPr>
          <p:cNvSpPr/>
          <p:nvPr/>
        </p:nvSpPr>
        <p:spPr>
          <a:xfrm>
            <a:off x="58004" y="7143776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A352F679-5C0A-B749-AD60-4831CDF567D9}"/>
              </a:ext>
            </a:extLst>
          </p:cNvPr>
          <p:cNvSpPr/>
          <p:nvPr/>
        </p:nvSpPr>
        <p:spPr>
          <a:xfrm>
            <a:off x="58004" y="6523229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784673"/>
            <a:ext cx="6754598" cy="43301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5009866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1A59B4C-F936-D44E-B90B-E6458E8DFB5E}"/>
              </a:ext>
            </a:extLst>
          </p:cNvPr>
          <p:cNvSpPr/>
          <p:nvPr/>
        </p:nvSpPr>
        <p:spPr>
          <a:xfrm>
            <a:off x="58004" y="4414918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80204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189094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576182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F184773-05EA-404C-9A6D-15233C400BA8}"/>
              </a:ext>
            </a:extLst>
          </p:cNvPr>
          <p:cNvSpPr/>
          <p:nvPr/>
        </p:nvSpPr>
        <p:spPr>
          <a:xfrm>
            <a:off x="58004" y="196327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589456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Table xx. </a:t>
            </a:r>
            <a:r>
              <a:rPr lang="en-US" altLang="ja-JP" sz="1050" dirty="0">
                <a:latin typeface="Arial"/>
                <a:cs typeface="Arial"/>
              </a:rPr>
              <a:t>Primers Used for generating NRC4 variants by Golden Gate cloning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9659774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532792" cy="8556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syn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syn 29a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D3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V5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V6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N7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F8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9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10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E11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12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3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4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Q15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6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7A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A2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D3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A4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5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6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7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F8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9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V10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N12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13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8710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/>
                <a:cs typeface="Arial"/>
              </a:rPr>
              <a:t>AA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latin typeface="Arial"/>
                <a:cs typeface="Arial"/>
              </a:rPr>
              <a:t>AAT</a:t>
            </a:r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CGAACCCCCTTTAGCGCTCCCTATTA</a:t>
            </a: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caGCTGTTGTTAACTTC</a:t>
            </a:r>
            <a:endParaRPr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ACGCTGcaGTTAACTTCTTAG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ACGCTGTTGcTAACTTCTTAGTTG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 err="1">
                <a:latin typeface="Arial"/>
                <a:cs typeface="Arial"/>
              </a:rPr>
              <a:t>TAATGGCTGACGCTGTTGTTgcaTTCTTAGTTGAAAATTTAC</a:t>
            </a:r>
            <a:endParaRPr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gcaTTAGTTGAAAATTT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gcAGTTGAAAATTTA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cTGAAAATTTACTG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cAAATTTACTGCAA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gcaTTACTGCAATTG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AATgcACTGCAATTGCTG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gcaCAATTGCTGACGGAC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gcATTGCTGACGGACAAT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gcaCTG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TTAGTTGAAAATTTACTGCAATTGgctACGGACAATGTTAAATTAATAG</a:t>
            </a: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aaGACGCTGTTGTTAA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aGCTGTTGTTAACTTC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aaGTTGTTAACTTCTTAG</a:t>
            </a:r>
            <a:endParaRPr kumimoji="1" lang="en-US" altLang="ja-JP" sz="1000" dirty="0">
              <a:latin typeface="Arial"/>
              <a:cs typeface="Arial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aaGTTAACTTCTTAG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aaAACTTCTTAGT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gaaTTCTTAGTTGAAAATTT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gaaTTAGTTGAAAATTTA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gaAGTTGAAAATTTA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aaGAAAATTTACTGC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gaaTTACTGCAATTGC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kumimoji="1" lang="en-US" altLang="ja-JP" sz="1000" dirty="0" err="1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 err="1">
                <a:latin typeface="Arial"/>
                <a:cs typeface="Arial"/>
              </a:rPr>
              <a:t>TAATGGCTGACGCTGTTGTTAACTTCTTAGTTGAAAATgaACTGCAATTGCTGAC</a:t>
            </a:r>
            <a:endParaRPr kumimoji="1" lang="en-US" altLang="ja-JP" sz="1000" dirty="0">
              <a:latin typeface="Arial"/>
              <a:cs typeface="Arial"/>
            </a:endParaRPr>
          </a:p>
        </p:txBody>
      </p:sp>
      <p:sp>
        <p:nvSpPr>
          <p:cNvPr id="93" name="テキスト ボックス 23">
            <a:extLst>
              <a:ext uri="{FF2B5EF4-FFF2-40B4-BE49-F238E27FC236}">
                <a16:creationId xmlns:a16="http://schemas.microsoft.com/office/drawing/2014/main" id="{89706E7E-A53D-7E4D-A73F-128C61557D6D}"/>
              </a:ext>
            </a:extLst>
          </p:cNvPr>
          <p:cNvSpPr txBox="1"/>
          <p:nvPr/>
        </p:nvSpPr>
        <p:spPr>
          <a:xfrm>
            <a:off x="5208653" y="998759"/>
            <a:ext cx="1463862" cy="855618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</a:t>
            </a:r>
            <a:r>
              <a:rPr lang="it-IT" altLang="ja-JP" sz="1000" baseline="-25000" dirty="0">
                <a:latin typeface="Arial" charset="0"/>
                <a:ea typeface="Arial" charset="0"/>
                <a:cs typeface="Arial" charset="0"/>
              </a:rPr>
              <a:t>1-29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</a:t>
            </a:r>
            <a:r>
              <a:rPr lang="it-IT" altLang="ja-JP" sz="1000" baseline="-25000" dirty="0">
                <a:latin typeface="Arial" charset="0"/>
                <a:ea typeface="Arial" charset="0"/>
                <a:cs typeface="Arial" charset="0"/>
              </a:rPr>
              <a:t>1-29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069580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Rectangle 89">
            <a:extLst>
              <a:ext uri="{FF2B5EF4-FFF2-40B4-BE49-F238E27FC236}">
                <a16:creationId xmlns:a16="http://schemas.microsoft.com/office/drawing/2014/main" id="{148F2A4E-750C-CA49-9AFF-2369BFAC34EA}"/>
              </a:ext>
            </a:extLst>
          </p:cNvPr>
          <p:cNvSpPr/>
          <p:nvPr/>
        </p:nvSpPr>
        <p:spPr>
          <a:xfrm>
            <a:off x="58004" y="7292160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A352F679-5C0A-B749-AD60-4831CDF567D9}"/>
              </a:ext>
            </a:extLst>
          </p:cNvPr>
          <p:cNvSpPr/>
          <p:nvPr/>
        </p:nvSpPr>
        <p:spPr>
          <a:xfrm>
            <a:off x="58004" y="6385478"/>
            <a:ext cx="6754598" cy="44880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8148961D-17EC-4F4A-931C-E5D2B35273A2}"/>
              </a:ext>
            </a:extLst>
          </p:cNvPr>
          <p:cNvSpPr/>
          <p:nvPr/>
        </p:nvSpPr>
        <p:spPr>
          <a:xfrm>
            <a:off x="58004" y="5481230"/>
            <a:ext cx="6754598" cy="43301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794C23B0-47AD-DE47-8419-86D24689AEA3}"/>
              </a:ext>
            </a:extLst>
          </p:cNvPr>
          <p:cNvSpPr/>
          <p:nvPr/>
        </p:nvSpPr>
        <p:spPr>
          <a:xfrm>
            <a:off x="58004" y="4554244"/>
            <a:ext cx="6754598" cy="46568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9AF246CF-9BB9-214B-9AD0-CA20C5A5C8CC}"/>
              </a:ext>
            </a:extLst>
          </p:cNvPr>
          <p:cNvSpPr/>
          <p:nvPr/>
        </p:nvSpPr>
        <p:spPr>
          <a:xfrm>
            <a:off x="58004" y="3640111"/>
            <a:ext cx="6754598" cy="46531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5AAB0EA-0EE2-F046-BD5F-4E07FE2CA1F8}"/>
              </a:ext>
            </a:extLst>
          </p:cNvPr>
          <p:cNvSpPr/>
          <p:nvPr/>
        </p:nvSpPr>
        <p:spPr>
          <a:xfrm>
            <a:off x="58004" y="302690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8EEEA8ED-DF50-F142-844E-AB93237D27FC}"/>
              </a:ext>
            </a:extLst>
          </p:cNvPr>
          <p:cNvSpPr/>
          <p:nvPr/>
        </p:nvSpPr>
        <p:spPr>
          <a:xfrm>
            <a:off x="58004" y="2116331"/>
            <a:ext cx="6754598" cy="458367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79C0064-7685-404C-B7D9-59F421A7E266}"/>
              </a:ext>
            </a:extLst>
          </p:cNvPr>
          <p:cNvSpPr/>
          <p:nvPr/>
        </p:nvSpPr>
        <p:spPr>
          <a:xfrm>
            <a:off x="58004" y="1350357"/>
            <a:ext cx="6754598" cy="313765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2" name="テキスト ボックス 16">
            <a:extLst>
              <a:ext uri="{FF2B5EF4-FFF2-40B4-BE49-F238E27FC236}">
                <a16:creationId xmlns:a16="http://schemas.microsoft.com/office/drawing/2014/main" id="{EA1D7486-26F7-7149-88C9-58F1A941F08D}"/>
              </a:ext>
            </a:extLst>
          </p:cNvPr>
          <p:cNvSpPr txBox="1"/>
          <p:nvPr/>
        </p:nvSpPr>
        <p:spPr>
          <a:xfrm>
            <a:off x="33290" y="422703"/>
            <a:ext cx="24609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upplementary Table xx. </a:t>
            </a:r>
            <a:r>
              <a:rPr lang="en-US" altLang="ja-JP" sz="1050" dirty="0">
                <a:latin typeface="Arial"/>
                <a:cs typeface="Arial"/>
              </a:rPr>
              <a:t>Continued.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3" name="テキスト ボックス 17">
            <a:extLst>
              <a:ext uri="{FF2B5EF4-FFF2-40B4-BE49-F238E27FC236}">
                <a16:creationId xmlns:a16="http://schemas.microsoft.com/office/drawing/2014/main" id="{E5BCFA6A-4C52-8E40-ADC8-0EC145478D29}"/>
              </a:ext>
            </a:extLst>
          </p:cNvPr>
          <p:cNvSpPr txBox="1"/>
          <p:nvPr/>
        </p:nvSpPr>
        <p:spPr>
          <a:xfrm>
            <a:off x="182344" y="711644"/>
            <a:ext cx="55335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Name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5" name="テキスト ボックス 18">
            <a:extLst>
              <a:ext uri="{FF2B5EF4-FFF2-40B4-BE49-F238E27FC236}">
                <a16:creationId xmlns:a16="http://schemas.microsoft.com/office/drawing/2014/main" id="{2AEE24A3-BC69-9A4B-93BF-8B9B4B04E905}"/>
              </a:ext>
            </a:extLst>
          </p:cNvPr>
          <p:cNvSpPr txBox="1"/>
          <p:nvPr/>
        </p:nvSpPr>
        <p:spPr>
          <a:xfrm>
            <a:off x="1816427" y="711644"/>
            <a:ext cx="125066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Sequence (5’&gt;3’)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sp>
        <p:nvSpPr>
          <p:cNvPr id="46" name="テキスト ボックス 19">
            <a:extLst>
              <a:ext uri="{FF2B5EF4-FFF2-40B4-BE49-F238E27FC236}">
                <a16:creationId xmlns:a16="http://schemas.microsoft.com/office/drawing/2014/main" id="{0AEACA27-73E9-334D-91A5-E0A0BC92B942}"/>
              </a:ext>
            </a:extLst>
          </p:cNvPr>
          <p:cNvSpPr txBox="1"/>
          <p:nvPr/>
        </p:nvSpPr>
        <p:spPr>
          <a:xfrm>
            <a:off x="5195590" y="716807"/>
            <a:ext cx="141737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50" b="1" dirty="0">
                <a:latin typeface="Arial"/>
                <a:cs typeface="Arial"/>
              </a:rPr>
              <a:t>Usage in this study</a:t>
            </a:r>
            <a:endParaRPr kumimoji="1" lang="ja-JP" altLang="en-US" sz="1050" dirty="0">
              <a:latin typeface="Arial"/>
              <a:cs typeface="Arial"/>
            </a:endParaRPr>
          </a:p>
        </p:txBody>
      </p:sp>
      <p:cxnSp>
        <p:nvCxnSpPr>
          <p:cNvPr id="48" name="直線コネクタ 20">
            <a:extLst>
              <a:ext uri="{FF2B5EF4-FFF2-40B4-BE49-F238E27FC236}">
                <a16:creationId xmlns:a16="http://schemas.microsoft.com/office/drawing/2014/main" id="{5FD7A773-5199-8B4F-B10F-120103137820}"/>
              </a:ext>
            </a:extLst>
          </p:cNvPr>
          <p:cNvCxnSpPr/>
          <p:nvPr/>
        </p:nvCxnSpPr>
        <p:spPr>
          <a:xfrm flipV="1">
            <a:off x="51175" y="975666"/>
            <a:ext cx="6754598" cy="2006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0" name="直線コネクタ 21">
            <a:extLst>
              <a:ext uri="{FF2B5EF4-FFF2-40B4-BE49-F238E27FC236}">
                <a16:creationId xmlns:a16="http://schemas.microsoft.com/office/drawing/2014/main" id="{E6A126DE-3919-9A43-94F7-C6D9EB177297}"/>
              </a:ext>
            </a:extLst>
          </p:cNvPr>
          <p:cNvCxnSpPr/>
          <p:nvPr/>
        </p:nvCxnSpPr>
        <p:spPr>
          <a:xfrm>
            <a:off x="51175" y="694242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22">
            <a:extLst>
              <a:ext uri="{FF2B5EF4-FFF2-40B4-BE49-F238E27FC236}">
                <a16:creationId xmlns:a16="http://schemas.microsoft.com/office/drawing/2014/main" id="{BA753104-4C82-B949-850A-96F48C6983B5}"/>
              </a:ext>
            </a:extLst>
          </p:cNvPr>
          <p:cNvCxnSpPr/>
          <p:nvPr/>
        </p:nvCxnSpPr>
        <p:spPr>
          <a:xfrm>
            <a:off x="51175" y="7660764"/>
            <a:ext cx="6754598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テキスト ボックス 23">
            <a:extLst>
              <a:ext uri="{FF2B5EF4-FFF2-40B4-BE49-F238E27FC236}">
                <a16:creationId xmlns:a16="http://schemas.microsoft.com/office/drawing/2014/main" id="{F3A84349-F144-F445-88B3-7050FCE92CE6}"/>
              </a:ext>
            </a:extLst>
          </p:cNvPr>
          <p:cNvSpPr txBox="1"/>
          <p:nvPr/>
        </p:nvSpPr>
        <p:spPr>
          <a:xfrm>
            <a:off x="187855" y="1003487"/>
            <a:ext cx="1494107" cy="65556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14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Q15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16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17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T18E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L9A/V10A/L14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L9E/V10E/L14E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2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ZAR1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PP8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PP13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Os03g30910 24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Pik2 23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RPM1 17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MLA10 19aa 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Fw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NRC4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Rv</a:t>
            </a:r>
            <a:r>
              <a:rPr lang="en-GB" altLang="ja-JP" sz="10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GB" altLang="ja-JP" sz="1000" dirty="0" err="1">
                <a:latin typeface="Arial" charset="0"/>
                <a:ea typeface="Arial" charset="0"/>
                <a:cs typeface="Arial" charset="0"/>
              </a:rPr>
              <a:t>BsaI</a:t>
            </a:r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68" name="テキスト ボックス 24">
            <a:extLst>
              <a:ext uri="{FF2B5EF4-FFF2-40B4-BE49-F238E27FC236}">
                <a16:creationId xmlns:a16="http://schemas.microsoft.com/office/drawing/2014/main" id="{60F2F024-F9CC-194F-A7B3-E35D0704CBE7}"/>
              </a:ext>
            </a:extLst>
          </p:cNvPr>
          <p:cNvSpPr txBox="1"/>
          <p:nvPr/>
        </p:nvSpPr>
        <p:spPr>
          <a:xfrm>
            <a:off x="1816427" y="1003487"/>
            <a:ext cx="3379163" cy="67095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gaaCAATTGCTGACGGAC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gaATTGCTGACGGACAAT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gaaCTGACGGACAATGTTAAATTAATAG</a:t>
            </a:r>
            <a:endParaRPr kumimoji="1" lang="en-US" altLang="ja-JP" sz="1000" dirty="0">
              <a:latin typeface="Arial"/>
              <a:cs typeface="Arial"/>
            </a:endParaRP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gaaACGGACAATGTTAAATTAATA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lang="en-US" altLang="ja-JP" sz="1000" dirty="0">
                <a:latin typeface="Arial"/>
                <a:cs typeface="Arial"/>
              </a:rPr>
              <a:t>TAATGGCTGACGCTGTTGTTAACTTCTTAGTTGAAAATTTACTGCAATTGCTGgaaGACAATGTTAAATTAATAG</a:t>
            </a:r>
          </a:p>
          <a:p>
            <a:r>
              <a:rPr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T</a:t>
            </a:r>
            <a:r>
              <a:rPr lang="en-US" altLang="ja-JP" sz="1000" dirty="0">
                <a:latin typeface="Arial"/>
                <a:cs typeface="Arial"/>
              </a:rPr>
              <a:t>AATGGCTGACGCTGTTGTTAACTTCgcAGcTGAAAATTTAgcaCAATTGCTGACGGAC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CGCTGTTGTTAACTTCgaAGaaGAAAATTTAgaaCAATTGCTGACGGAC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AATGTGGCTGTTGAGTTCCTGGTTCAAAATCTCATGCAATTGCTAACGGACAATGTTAAATTAATAG</a:t>
            </a:r>
          </a:p>
          <a:p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TGGACGCTGTTGTAACAGTGTTTTTAGAGAAAACCTTGAACATCCTC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GAAGCATTTGTGTCGTTTGGACTTGAGAAGCTTTGGGATCTCCTG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TAGATGCGATCACGGAGTTCGTTGTGGGAAAGATCGGCAACTATCTC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AAAGTGTCGTTGTTACTGCTGCTGAGGGTGCTGTGAAAACACTGCTGGGTAAACTGGGCTCTTTTCTT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AGTTGGTGGTAGGTGCTTCCGAAGCCACCATGAAATCTCTCTTGGGCAAGCTGGGCAATCTTCTA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CTTCGGCTACTGTTGATTTTGGGATCGGACGGATTCTTAGTGTCCTG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AATGGATATTGTCACCGGTGCCATTTCCAACCTGATTCCCAAGTTGGGGGAGCTACTCACGGACAATGTTAAATTAATAG</a:t>
            </a:r>
          </a:p>
          <a:p>
            <a:r>
              <a:rPr kumimoji="1" lang="en-US" altLang="ja-JP" sz="1000" dirty="0">
                <a:latin typeface="Arial"/>
                <a:cs typeface="Arial"/>
              </a:rPr>
              <a:t>AAT</a:t>
            </a:r>
            <a:r>
              <a:rPr kumimoji="1" lang="en-US" altLang="ja-JP" sz="1000" dirty="0">
                <a:solidFill>
                  <a:srgbClr val="FF0000"/>
                </a:solidFill>
                <a:latin typeface="Arial"/>
                <a:cs typeface="Arial"/>
              </a:rPr>
              <a:t>GGTCTC</a:t>
            </a:r>
            <a:r>
              <a:rPr kumimoji="1" lang="en-US" altLang="ja-JP" sz="1000" dirty="0">
                <a:latin typeface="Arial"/>
                <a:cs typeface="Arial"/>
              </a:rPr>
              <a:t>TCGAACCCTGTGTGGCCTTGGATCCAG</a:t>
            </a: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58D77958-6BF0-2C4C-A776-D95667DFF8A5}"/>
              </a:ext>
            </a:extLst>
          </p:cNvPr>
          <p:cNvSpPr txBox="1"/>
          <p:nvPr/>
        </p:nvSpPr>
        <p:spPr>
          <a:xfrm>
            <a:off x="5208653" y="998759"/>
            <a:ext cx="1534394" cy="67095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kumimoji="1" lang="en-US" altLang="ja-JP" sz="1000" dirty="0">
              <a:latin typeface="Arial"/>
              <a:cs typeface="Arial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US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endParaRPr lang="it-IT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chimera</a:t>
            </a: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endParaRPr lang="en-GB" altLang="ja-JP" sz="1000" dirty="0">
              <a:latin typeface="Arial" charset="0"/>
              <a:ea typeface="Arial" charset="0"/>
              <a:cs typeface="Arial" charset="0"/>
            </a:endParaRP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NRC4 MADA </a:t>
            </a:r>
            <a:r>
              <a:rPr lang="it-IT" altLang="ja-JP" sz="1000" dirty="0" err="1">
                <a:latin typeface="Arial" charset="0"/>
                <a:ea typeface="Arial" charset="0"/>
                <a:cs typeface="Arial" charset="0"/>
              </a:rPr>
              <a:t>mutation</a:t>
            </a:r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 /</a:t>
            </a:r>
          </a:p>
          <a:p>
            <a:r>
              <a:rPr lang="it-IT" altLang="ja-JP" sz="1000" dirty="0">
                <a:latin typeface="Arial" charset="0"/>
                <a:ea typeface="Arial" charset="0"/>
                <a:cs typeface="Arial" charset="0"/>
              </a:rPr>
              <a:t>MADA chimera</a:t>
            </a:r>
          </a:p>
        </p:txBody>
      </p:sp>
    </p:spTree>
    <p:extLst>
      <p:ext uri="{BB962C8B-B14F-4D97-AF65-F5344CB8AC3E}">
        <p14:creationId xmlns:p14="http://schemas.microsoft.com/office/powerpoint/2010/main" val="32736987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3</TotalTime>
  <Words>400</Words>
  <Application>Microsoft Macintosh PowerPoint</Application>
  <PresentationFormat>A4 Paper (210x297 mm)</PresentationFormat>
  <Paragraphs>24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aki Adachi (TSL)</dc:creator>
  <cp:lastModifiedBy>Hiroaki Adachi (TSL)</cp:lastModifiedBy>
  <cp:revision>29</cp:revision>
  <dcterms:created xsi:type="dcterms:W3CDTF">2019-04-29T00:03:08Z</dcterms:created>
  <dcterms:modified xsi:type="dcterms:W3CDTF">2019-06-28T16:24:56Z</dcterms:modified>
</cp:coreProperties>
</file>